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0E458E-79C8-4220-9844-C92D6B082431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D4F521-00D9-43E9-B517-882504AF5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08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an omit bottom one</a:t>
            </a:r>
          </a:p>
          <a:p>
            <a:endParaRPr lang="en-US" dirty="0" smtClean="0"/>
          </a:p>
          <a:p>
            <a:r>
              <a:rPr lang="en-US" dirty="0" smtClean="0"/>
              <a:t>S1 a and</a:t>
            </a:r>
            <a:r>
              <a:rPr lang="en-US" baseline="0" dirty="0" smtClean="0"/>
              <a:t> B are with </a:t>
            </a:r>
            <a:r>
              <a:rPr lang="en-US" baseline="0" dirty="0" err="1" smtClean="0"/>
              <a:t>differnet</a:t>
            </a:r>
            <a:r>
              <a:rPr lang="en-US" baseline="0" dirty="0" smtClean="0"/>
              <a:t> parp inhibitor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D323BF-730A-4EB0-88D8-DBDBE465C2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6219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ours to </a:t>
            </a:r>
            <a:r>
              <a:rPr lang="en-US" dirty="0" err="1" smtClean="0"/>
              <a:t>hr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D323BF-730A-4EB0-88D8-DBDBE465C29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8713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I changed </a:t>
            </a:r>
            <a:r>
              <a:rPr lang="en-US" sz="1200" dirty="0" err="1" smtClean="0"/>
              <a:t>DNAPKi</a:t>
            </a:r>
            <a:r>
              <a:rPr lang="en-US" sz="1200" baseline="0" dirty="0" smtClean="0"/>
              <a:t> to NU7441, the font format and size may need to adjust like other figures.</a:t>
            </a:r>
            <a:endParaRPr lang="en-US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D323BF-730A-4EB0-88D8-DBDBE465C29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7447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D323BF-730A-4EB0-88D8-DBDBE465C29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4570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904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961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00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761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691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667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066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917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06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23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003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A801E-CD9F-4C0A-A748-543CAE238B59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8E1C4-0156-4A06-88B3-9558F1D9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66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7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2251" y="237411"/>
            <a:ext cx="2805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S1</a:t>
            </a:r>
            <a:endParaRPr lang="en-US" b="1" dirty="0"/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/>
          </p:nvPr>
        </p:nvGraphicFramePr>
        <p:xfrm>
          <a:off x="1326463" y="1972892"/>
          <a:ext cx="4111625" cy="4238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4" imgW="4111669" imgH="4238653" progId="Prism8.Document">
                  <p:embed/>
                </p:oleObj>
              </mc:Choice>
              <mc:Fallback>
                <p:oleObj name="Prism 8" r:id="rId4" imgW="4111669" imgH="4238653" progId="Prism8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26463" y="1972892"/>
                        <a:ext cx="4111625" cy="4238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5438088" y="1972892"/>
          <a:ext cx="5995988" cy="345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6" imgW="5996260" imgH="3457839" progId="Prism8.Document">
                  <p:embed/>
                </p:oleObj>
              </mc:Choice>
              <mc:Fallback>
                <p:oleObj name="Prism 8" r:id="rId6" imgW="5996260" imgH="3457839" progId="Prism8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38088" y="1972892"/>
                        <a:ext cx="5995988" cy="345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5721254" y="160395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66884" y="160356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455238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3173" y="225631"/>
            <a:ext cx="276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S2 </a:t>
            </a:r>
            <a:endParaRPr lang="en-US" b="1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184150" y="993775"/>
          <a:ext cx="4413250" cy="4854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8" r:id="rId4" imgW="4413823" imgH="4854516" progId="Prism8.Document">
                  <p:embed/>
                </p:oleObj>
              </mc:Choice>
              <mc:Fallback>
                <p:oleObj name="Prism 8" r:id="rId4" imgW="4413823" imgH="4854516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4150" y="993775"/>
                        <a:ext cx="4413250" cy="4854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4057650" y="1004888"/>
          <a:ext cx="4135438" cy="4891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6" imgW="4134718" imgH="4891252" progId="Prism8.Document">
                  <p:embed/>
                </p:oleObj>
              </mc:Choice>
              <mc:Fallback>
                <p:oleObj name="Prism 8" r:id="rId6" imgW="4134718" imgH="4891252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057650" y="1004888"/>
                        <a:ext cx="4135438" cy="4891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/>
          </p:nvPr>
        </p:nvGraphicFramePr>
        <p:xfrm>
          <a:off x="7583488" y="968375"/>
          <a:ext cx="4551362" cy="4900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8" r:id="rId8" imgW="4551035" imgH="4900256" progId="Prism8.Document">
                  <p:embed/>
                </p:oleObj>
              </mc:Choice>
              <mc:Fallback>
                <p:oleObj name="Prism 8" r:id="rId8" imgW="4551035" imgH="4900256" progId="Prism8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583488" y="968375"/>
                        <a:ext cx="4551362" cy="4900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34679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74753373-6458-4C45-89ED-29416443E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320" y="228600"/>
            <a:ext cx="2556562" cy="370800"/>
          </a:xfrm>
        </p:spPr>
        <p:txBody>
          <a:bodyPr anchor="t">
            <a:normAutofit/>
          </a:bodyPr>
          <a:lstStyle/>
          <a:p>
            <a:r>
              <a:rPr lang="en-US" sz="1800" b="1" dirty="0">
                <a:latin typeface="+mn-lt"/>
              </a:rPr>
              <a:t>Supplementary </a:t>
            </a:r>
            <a:r>
              <a:rPr lang="en-US" sz="1800" b="1" dirty="0" smtClean="0">
                <a:latin typeface="+mn-lt"/>
              </a:rPr>
              <a:t>Figure S3</a:t>
            </a:r>
            <a:endParaRPr lang="en-US" sz="1800" b="1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171446" y="1977188"/>
            <a:ext cx="5175949" cy="2449294"/>
            <a:chOff x="1571246" y="1316788"/>
            <a:chExt cx="5175949" cy="2449294"/>
          </a:xfrm>
        </p:grpSpPr>
        <p:sp>
          <p:nvSpPr>
            <p:cNvPr id="31" name="TextBox 30"/>
            <p:cNvSpPr txBox="1"/>
            <p:nvPr/>
          </p:nvSpPr>
          <p:spPr>
            <a:xfrm>
              <a:off x="1571246" y="2678528"/>
              <a:ext cx="151676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P-MAPK/CDK </a:t>
              </a:r>
            </a:p>
            <a:p>
              <a:pPr algn="ctr"/>
              <a:r>
                <a:rPr lang="en-US" dirty="0" smtClean="0"/>
                <a:t>substrate</a:t>
              </a:r>
              <a:endParaRPr lang="en-US" dirty="0"/>
            </a:p>
          </p:txBody>
        </p:sp>
        <p:pic>
          <p:nvPicPr>
            <p:cNvPr id="32" name="Picture 31"/>
            <p:cNvPicPr>
              <a:picLocks/>
            </p:cNvPicPr>
            <p:nvPr/>
          </p:nvPicPr>
          <p:blipFill>
            <a:blip r:embed="rId3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089595" y="2727374"/>
              <a:ext cx="3657600" cy="54864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33" name="Picture 32"/>
            <p:cNvPicPr>
              <a:picLocks/>
            </p:cNvPicPr>
            <p:nvPr/>
          </p:nvPicPr>
          <p:blipFill rotWithShape="1">
            <a:blip r:embed="rId5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t="12889" b="13265"/>
            <a:stretch/>
          </p:blipFill>
          <p:spPr>
            <a:xfrm>
              <a:off x="3089595" y="3400322"/>
              <a:ext cx="3657600" cy="36576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34" name="TextBox 33"/>
            <p:cNvSpPr txBox="1"/>
            <p:nvPr/>
          </p:nvSpPr>
          <p:spPr>
            <a:xfrm>
              <a:off x="1926400" y="3388704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/>
                <a:t>β</a:t>
              </a:r>
              <a:r>
                <a:rPr lang="en-US" dirty="0" smtClean="0"/>
                <a:t>-actin</a:t>
              </a:r>
              <a:endParaRPr lang="en-US" dirty="0"/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3140395" y="1733348"/>
              <a:ext cx="3519179" cy="923330"/>
              <a:chOff x="3358110" y="1371600"/>
              <a:chExt cx="3519179" cy="923330"/>
            </a:xfrm>
          </p:grpSpPr>
          <p:grpSp>
            <p:nvGrpSpPr>
              <p:cNvPr id="69" name="Group 68"/>
              <p:cNvGrpSpPr/>
              <p:nvPr/>
            </p:nvGrpSpPr>
            <p:grpSpPr>
              <a:xfrm>
                <a:off x="3358110" y="1371600"/>
                <a:ext cx="1687190" cy="923330"/>
                <a:chOff x="3358110" y="1371600"/>
                <a:chExt cx="1687190" cy="923330"/>
              </a:xfrm>
            </p:grpSpPr>
            <p:sp>
              <p:nvSpPr>
                <p:cNvPr id="75" name="TextBox 74"/>
                <p:cNvSpPr txBox="1"/>
                <p:nvPr/>
              </p:nvSpPr>
              <p:spPr>
                <a:xfrm>
                  <a:off x="3358110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 smtClean="0"/>
                    <a:t>-</a:t>
                  </a:r>
                </a:p>
                <a:p>
                  <a:pPr algn="ctr"/>
                  <a:r>
                    <a:rPr lang="en-US" b="1" dirty="0"/>
                    <a:t>-</a:t>
                  </a: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3828391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/>
                    <a:t>+</a:t>
                  </a:r>
                  <a:endParaRPr lang="en-US" b="1" dirty="0" smtClean="0"/>
                </a:p>
                <a:p>
                  <a:pPr algn="ctr"/>
                  <a:r>
                    <a:rPr lang="en-US" b="1" dirty="0"/>
                    <a:t>-</a:t>
                  </a: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4287637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 smtClean="0"/>
                    <a:t>-</a:t>
                  </a:r>
                </a:p>
                <a:p>
                  <a:pPr algn="ctr"/>
                  <a:r>
                    <a:rPr lang="en-US" b="1" dirty="0" smtClean="0"/>
                    <a:t>+</a:t>
                  </a:r>
                  <a:endParaRPr lang="en-US" b="1" dirty="0"/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4745218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/>
                    <a:t>+</a:t>
                  </a:r>
                  <a:endParaRPr lang="en-US" b="1" dirty="0" smtClean="0"/>
                </a:p>
                <a:p>
                  <a:pPr algn="ctr"/>
                  <a:r>
                    <a:rPr lang="en-US" b="1" dirty="0" smtClean="0"/>
                    <a:t>+</a:t>
                  </a:r>
                  <a:endParaRPr lang="en-US" b="1" dirty="0"/>
                </a:p>
              </p:txBody>
            </p:sp>
          </p:grpSp>
          <p:grpSp>
            <p:nvGrpSpPr>
              <p:cNvPr id="70" name="Group 69"/>
              <p:cNvGrpSpPr/>
              <p:nvPr/>
            </p:nvGrpSpPr>
            <p:grpSpPr>
              <a:xfrm>
                <a:off x="5190099" y="1371600"/>
                <a:ext cx="1687190" cy="923330"/>
                <a:chOff x="3358110" y="1371600"/>
                <a:chExt cx="1687190" cy="923330"/>
              </a:xfrm>
            </p:grpSpPr>
            <p:sp>
              <p:nvSpPr>
                <p:cNvPr id="71" name="TextBox 70"/>
                <p:cNvSpPr txBox="1"/>
                <p:nvPr/>
              </p:nvSpPr>
              <p:spPr>
                <a:xfrm>
                  <a:off x="3358110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 smtClean="0"/>
                    <a:t>-</a:t>
                  </a:r>
                </a:p>
                <a:p>
                  <a:pPr algn="ctr"/>
                  <a:r>
                    <a:rPr lang="en-US" b="1" dirty="0"/>
                    <a:t>-</a:t>
                  </a: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3828391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/>
                    <a:t>+</a:t>
                  </a:r>
                  <a:endParaRPr lang="en-US" b="1" dirty="0" smtClean="0"/>
                </a:p>
                <a:p>
                  <a:pPr algn="ctr"/>
                  <a:r>
                    <a:rPr lang="en-US" b="1" dirty="0"/>
                    <a:t>-</a:t>
                  </a: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4287637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 smtClean="0"/>
                    <a:t>-</a:t>
                  </a:r>
                </a:p>
                <a:p>
                  <a:pPr algn="ctr"/>
                  <a:r>
                    <a:rPr lang="en-US" b="1" dirty="0" smtClean="0"/>
                    <a:t>+</a:t>
                  </a:r>
                  <a:endParaRPr lang="en-US" b="1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4745218" y="1371600"/>
                  <a:ext cx="300082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b="1" dirty="0" smtClean="0"/>
                    <a:t>+</a:t>
                  </a:r>
                </a:p>
                <a:p>
                  <a:pPr algn="ctr"/>
                  <a:r>
                    <a:rPr lang="en-US" b="1" dirty="0"/>
                    <a:t>+</a:t>
                  </a:r>
                  <a:endParaRPr lang="en-US" b="1" dirty="0" smtClean="0"/>
                </a:p>
                <a:p>
                  <a:pPr algn="ctr"/>
                  <a:r>
                    <a:rPr lang="en-US" b="1" dirty="0" smtClean="0"/>
                    <a:t>+</a:t>
                  </a:r>
                  <a:endParaRPr lang="en-US" b="1" dirty="0"/>
                </a:p>
              </p:txBody>
            </p:sp>
          </p:grpSp>
        </p:grpSp>
        <p:cxnSp>
          <p:nvCxnSpPr>
            <p:cNvPr id="38" name="Straight Connector 37"/>
            <p:cNvCxnSpPr/>
            <p:nvPr/>
          </p:nvCxnSpPr>
          <p:spPr>
            <a:xfrm>
              <a:off x="3224577" y="1733348"/>
              <a:ext cx="15544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5043953" y="1733348"/>
              <a:ext cx="15544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3768216" y="1316788"/>
              <a:ext cx="6423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0 </a:t>
              </a:r>
              <a:r>
                <a:rPr lang="en-US" dirty="0" err="1" smtClean="0"/>
                <a:t>hrs</a:t>
              </a:r>
              <a:endParaRPr lang="en-US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491934" y="1316788"/>
              <a:ext cx="8170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0.5 </a:t>
              </a:r>
              <a:r>
                <a:rPr lang="en-US" dirty="0" err="1" smtClean="0"/>
                <a:t>hrs</a:t>
              </a:r>
              <a:endParaRPr lang="en-US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942358" y="1706639"/>
              <a:ext cx="1008610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IR</a:t>
              </a:r>
            </a:p>
            <a:p>
              <a:pPr algn="ctr"/>
              <a:r>
                <a:rPr lang="en-US" dirty="0" smtClean="0"/>
                <a:t>NU7441</a:t>
              </a:r>
            </a:p>
            <a:p>
              <a:pPr algn="ctr"/>
              <a:r>
                <a:rPr lang="en-US" dirty="0" err="1" smtClean="0"/>
                <a:t>Olaparib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932671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15051" y="225631"/>
            <a:ext cx="30475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</a:t>
            </a:r>
            <a:r>
              <a:rPr lang="en-US" b="1" smtClean="0"/>
              <a:t>Figure S4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23540" y="104599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759827" y="101892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63525" y="1350963"/>
          <a:ext cx="5295900" cy="4033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8" r:id="rId4" imgW="5296516" imgH="4034085" progId="Prism8.Document">
                  <p:embed/>
                </p:oleObj>
              </mc:Choice>
              <mc:Fallback>
                <p:oleObj name="Prism 8" r:id="rId4" imgW="5296516" imgH="4034085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3525" y="1350963"/>
                        <a:ext cx="5295900" cy="4033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5408613" y="1323975"/>
          <a:ext cx="6788150" cy="4052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8" r:id="rId6" imgW="6787478" imgH="4052453" progId="Prism8.Document">
                  <p:embed/>
                </p:oleObj>
              </mc:Choice>
              <mc:Fallback>
                <p:oleObj name="Prism 8" r:id="rId6" imgW="6787478" imgH="4052453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08613" y="1323975"/>
                        <a:ext cx="6788150" cy="4052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12158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Widescreen</PresentationFormat>
  <Paragraphs>49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Supplementary Figure S3</vt:lpstr>
      <vt:lpstr>PowerPoint Presentation</vt:lpstr>
    </vt:vector>
  </TitlesOfParts>
  <Company>UAB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, Eddy Shih-Hsin</dc:creator>
  <cp:lastModifiedBy>Yang, Eddy Shih-Hsin</cp:lastModifiedBy>
  <cp:revision>1</cp:revision>
  <dcterms:created xsi:type="dcterms:W3CDTF">2020-04-10T14:27:29Z</dcterms:created>
  <dcterms:modified xsi:type="dcterms:W3CDTF">2020-04-10T14:27:52Z</dcterms:modified>
</cp:coreProperties>
</file>